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5FA1A8-53A3-9A91-DC89-83CCFE7706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D8BCC5C-9645-5B45-F2A0-AF2FB493C9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83877A-CD43-3C6B-65C8-C467698CA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EE7BA2-BF7D-FE7C-0018-0552AF826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2C4CB2-A25A-080B-D128-E426FF709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315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B1CC4A-5B35-7EA0-CBA0-6521EA639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B2C12FB-5A5A-D6F8-6E8B-FD67CF59BE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6E883E-FCA4-510C-8385-AED667464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BDEC2C-2534-DC2A-B3D0-A601721AA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489EEA-7BCF-A2D2-3005-2CE02A68D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0478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075C54-0922-8371-F908-019D1565B3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44ABA01-9C80-5FF0-8ABC-13B71F8D20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13F27A-536B-7FA2-A6F7-6DB7DD8CA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BEB688-CC1A-9FD6-68A5-A81927A30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CEEC1E-5105-C77C-0D22-17580BA33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323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ABCF71-16DD-1B47-98B4-607CBCCE1D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CFA055-6BFA-C8E5-0C06-2AEFBD88D0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AC632A-C0A3-878A-D6D3-7347379B6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456715-D504-7180-1409-F0CFC724B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6C4F5E-7C5B-6790-80C6-610170017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663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7959D3-A97F-EB78-96B4-A79E15AFF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166A72-EB31-9398-C816-722147995A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978BA2-8A7D-8956-E748-81B8FF5DA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2E3AFA-F1C5-1579-0EB9-114C417E6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3F601D-F2C4-5021-1827-D74D2355D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14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BE3759-73BA-11D5-B56A-D533A2721F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D383188-45CE-6CD9-62DF-602A8E7FF6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FAD1D1E-8CBD-D7D2-E1EC-ECE389FA95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1925245-FBF7-69C7-583A-7BB1BA5E6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43692B-A585-5DF9-F923-0FC621D80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D57E49-7C1B-1175-EC46-24C612E6F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2723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78F3E4-4390-2EB5-D3F4-C3E8F0331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07CA58C-12E9-1DB4-4685-08C86FCBCE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C81DDC7-E9B3-9DD8-1A24-5F00423437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E8066B6-E5AA-71F0-D9EF-D2814F25A6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67AECB7-4264-0401-E4FE-DB21B4F510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815E0D-5F43-52A2-67BC-40159227A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E6CF519-2F6B-F168-DE1C-9F89D135B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74AF575-20E2-5CD2-5F8B-A90C23AB1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69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B740A1-D57D-F237-9386-349C0D048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1C92D50-98A0-0ED4-08BA-C30ABF19D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41FF17F-F687-1710-8089-8B20E4603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6E1C925-DED3-CAF9-B1CF-88D19B575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048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F118C91-FFC9-B3F2-6090-AA3B9ABE7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59D784B-5389-78CC-687E-680B7D181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E2C2848-3A54-DB27-F5E6-F260CB5D0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7544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FC3F3B-C436-BF3D-5FEE-3BD4CCDBB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29B4FD4-73FD-6845-F600-8DFFEFC59D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972648-4B97-3860-E108-4E1EF3D543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0ADF6C2-7558-B657-848B-5A68B22E1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F5D365-C49C-A4EE-7BDD-F09E74A4C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E1EEE0-EC71-2E71-A0E7-A2F711C3C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5697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90B527-3750-DD70-6D09-4DA51F668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B809E2C-9F4C-F050-6E72-FBD4ED232B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0DEDBB1-0496-491C-055F-EFF7A62E78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C4364D-C2F1-1EBC-22BF-EEEDBE7E1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72DD7F-C873-DC25-4C38-F6D20CD99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1F73C04-7BE6-CBBD-BF78-4D7AE1D97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8387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975B81F-8A79-54E3-372C-1B4DE9675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D65FEBF-6B81-FBA7-EE44-FFDAF93C4B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3D8257-164A-3BD5-8A62-857B3570B7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4A579-ABA0-45E4-8DE3-8FC2DFED4384}" type="datetimeFigureOut">
              <a:rPr lang="zh-CN" altLang="en-US" smtClean="0"/>
              <a:t>2026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13DD33-27CD-EAE8-14B1-3E84C8F27F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F0C544-8317-07C7-486C-C782E8C145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BAF85-AA29-4EA9-B049-4D86B87DB9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4318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F86E7FA-FE1E-36BD-337D-2B5A58B8F24E}"/>
              </a:ext>
            </a:extLst>
          </p:cNvPr>
          <p:cNvSpPr txBox="1"/>
          <p:nvPr/>
        </p:nvSpPr>
        <p:spPr>
          <a:xfrm>
            <a:off x="-1" y="0"/>
            <a:ext cx="92868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ration, Purification, and Characterization of SVA Target Protein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686A4056-25A1-F419-1218-5701066654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64" t="30918" r="25010" b="11465"/>
          <a:stretch>
            <a:fillRect/>
          </a:stretch>
        </p:blipFill>
        <p:spPr>
          <a:xfrm>
            <a:off x="7010400" y="1590674"/>
            <a:ext cx="3654029" cy="374332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3CDF93D-3CF6-9DDB-FF9E-84F59020005B}"/>
              </a:ext>
            </a:extLst>
          </p:cNvPr>
          <p:cNvSpPr txBox="1"/>
          <p:nvPr/>
        </p:nvSpPr>
        <p:spPr>
          <a:xfrm>
            <a:off x="1527569" y="1768604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0CDF8C7-862C-55E6-1012-957FAF3F7BB1}"/>
              </a:ext>
            </a:extLst>
          </p:cNvPr>
          <p:cNvSpPr txBox="1"/>
          <p:nvPr/>
        </p:nvSpPr>
        <p:spPr>
          <a:xfrm rot="18877941">
            <a:off x="2013317" y="1450881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E5291DA-C7FC-5C06-CCD5-37ECB929635D}"/>
              </a:ext>
            </a:extLst>
          </p:cNvPr>
          <p:cNvSpPr txBox="1"/>
          <p:nvPr/>
        </p:nvSpPr>
        <p:spPr>
          <a:xfrm rot="18877941">
            <a:off x="2430933" y="1451215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F077DA8-2BDD-BF5C-8078-12B50FA77B2B}"/>
              </a:ext>
            </a:extLst>
          </p:cNvPr>
          <p:cNvSpPr txBox="1"/>
          <p:nvPr/>
        </p:nvSpPr>
        <p:spPr>
          <a:xfrm rot="18877941">
            <a:off x="2807660" y="1462441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C256EA-508C-D17A-ABD0-F652A160D319}"/>
              </a:ext>
            </a:extLst>
          </p:cNvPr>
          <p:cNvSpPr txBox="1"/>
          <p:nvPr/>
        </p:nvSpPr>
        <p:spPr>
          <a:xfrm rot="18877941">
            <a:off x="3239329" y="1311468"/>
            <a:ext cx="1693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2-VP3-VP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3CDC683-74C9-F4A4-181A-12A3123FAD4C}"/>
              </a:ext>
            </a:extLst>
          </p:cNvPr>
          <p:cNvSpPr txBox="1"/>
          <p:nvPr/>
        </p:nvSpPr>
        <p:spPr>
          <a:xfrm>
            <a:off x="1223455" y="2048775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2B2F313-0093-B07D-942C-EB4146657E16}"/>
              </a:ext>
            </a:extLst>
          </p:cNvPr>
          <p:cNvSpPr txBox="1"/>
          <p:nvPr/>
        </p:nvSpPr>
        <p:spPr>
          <a:xfrm>
            <a:off x="1223455" y="2192688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F93EE6D-FE70-5B2F-A412-4332022B866C}"/>
              </a:ext>
            </a:extLst>
          </p:cNvPr>
          <p:cNvSpPr txBox="1"/>
          <p:nvPr/>
        </p:nvSpPr>
        <p:spPr>
          <a:xfrm>
            <a:off x="1223455" y="2336601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E9C3546-F722-18CF-F76A-B8E8D6CE1BAC}"/>
              </a:ext>
            </a:extLst>
          </p:cNvPr>
          <p:cNvSpPr txBox="1"/>
          <p:nvPr/>
        </p:nvSpPr>
        <p:spPr>
          <a:xfrm>
            <a:off x="1286286" y="2500465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72A9388-0174-BEF8-65BE-6A749FC5BFA7}"/>
              </a:ext>
            </a:extLst>
          </p:cNvPr>
          <p:cNvSpPr txBox="1"/>
          <p:nvPr/>
        </p:nvSpPr>
        <p:spPr>
          <a:xfrm>
            <a:off x="1286286" y="2664329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5864313-AC11-38DE-A729-5FCE2B2A5135}"/>
              </a:ext>
            </a:extLst>
          </p:cNvPr>
          <p:cNvSpPr txBox="1"/>
          <p:nvPr/>
        </p:nvSpPr>
        <p:spPr>
          <a:xfrm>
            <a:off x="1286285" y="2838168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364233B-D64E-CF9B-8C75-E5448291BA6E}"/>
              </a:ext>
            </a:extLst>
          </p:cNvPr>
          <p:cNvSpPr txBox="1"/>
          <p:nvPr/>
        </p:nvSpPr>
        <p:spPr>
          <a:xfrm>
            <a:off x="1286285" y="3096824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955815E-B8DE-16C2-148D-27C4EC4181BB}"/>
              </a:ext>
            </a:extLst>
          </p:cNvPr>
          <p:cNvSpPr txBox="1"/>
          <p:nvPr/>
        </p:nvSpPr>
        <p:spPr>
          <a:xfrm>
            <a:off x="1280329" y="3414731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144110D-4486-30DB-BA72-CD3FC3913AA6}"/>
              </a:ext>
            </a:extLst>
          </p:cNvPr>
          <p:cNvSpPr txBox="1"/>
          <p:nvPr/>
        </p:nvSpPr>
        <p:spPr>
          <a:xfrm>
            <a:off x="1280329" y="3943821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84ED08C-657C-E0B6-1529-FE8A3B16166D}"/>
              </a:ext>
            </a:extLst>
          </p:cNvPr>
          <p:cNvSpPr txBox="1"/>
          <p:nvPr/>
        </p:nvSpPr>
        <p:spPr>
          <a:xfrm>
            <a:off x="1280329" y="4472912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F29461F-5AE3-74CA-B233-8C67773CBFEE}"/>
              </a:ext>
            </a:extLst>
          </p:cNvPr>
          <p:cNvSpPr txBox="1"/>
          <p:nvPr/>
        </p:nvSpPr>
        <p:spPr>
          <a:xfrm>
            <a:off x="1184682" y="1850536"/>
            <a:ext cx="560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03D29C9-317C-97E9-DA7E-CB0EC158B0E4}"/>
              </a:ext>
            </a:extLst>
          </p:cNvPr>
          <p:cNvSpPr txBox="1"/>
          <p:nvPr/>
        </p:nvSpPr>
        <p:spPr>
          <a:xfrm>
            <a:off x="7031071" y="1808413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B8E925A-66F4-ABF1-812A-3C335A39D762}"/>
              </a:ext>
            </a:extLst>
          </p:cNvPr>
          <p:cNvSpPr txBox="1"/>
          <p:nvPr/>
        </p:nvSpPr>
        <p:spPr>
          <a:xfrm>
            <a:off x="7031071" y="1952326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C8EC4F2-30FE-2080-0AAC-B643BA68C511}"/>
              </a:ext>
            </a:extLst>
          </p:cNvPr>
          <p:cNvSpPr txBox="1"/>
          <p:nvPr/>
        </p:nvSpPr>
        <p:spPr>
          <a:xfrm>
            <a:off x="7031071" y="2096239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BA7383B-D57A-A248-91E9-7E6A1B1DC629}"/>
              </a:ext>
            </a:extLst>
          </p:cNvPr>
          <p:cNvSpPr txBox="1"/>
          <p:nvPr/>
        </p:nvSpPr>
        <p:spPr>
          <a:xfrm>
            <a:off x="7093902" y="2260103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51F15F7-3563-1D64-1A18-C83DA7B3B00F}"/>
              </a:ext>
            </a:extLst>
          </p:cNvPr>
          <p:cNvSpPr txBox="1"/>
          <p:nvPr/>
        </p:nvSpPr>
        <p:spPr>
          <a:xfrm>
            <a:off x="7093001" y="2452084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4C15682-31EF-4F09-CEFB-DBAB63997A46}"/>
              </a:ext>
            </a:extLst>
          </p:cNvPr>
          <p:cNvSpPr txBox="1"/>
          <p:nvPr/>
        </p:nvSpPr>
        <p:spPr>
          <a:xfrm>
            <a:off x="7093001" y="2627924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6435424-5BE9-A6DA-C37B-561170EB9A32}"/>
              </a:ext>
            </a:extLst>
          </p:cNvPr>
          <p:cNvSpPr txBox="1"/>
          <p:nvPr/>
        </p:nvSpPr>
        <p:spPr>
          <a:xfrm>
            <a:off x="7093901" y="2856462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56825A5-949C-9D68-DFA0-19F2017612D5}"/>
              </a:ext>
            </a:extLst>
          </p:cNvPr>
          <p:cNvSpPr txBox="1"/>
          <p:nvPr/>
        </p:nvSpPr>
        <p:spPr>
          <a:xfrm>
            <a:off x="7093001" y="3243478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CA5B886-B8D7-8088-78B2-75AC0BA1D129}"/>
              </a:ext>
            </a:extLst>
          </p:cNvPr>
          <p:cNvSpPr txBox="1"/>
          <p:nvPr/>
        </p:nvSpPr>
        <p:spPr>
          <a:xfrm>
            <a:off x="7087945" y="3746456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ADB64D8-534D-73E0-88E3-1AF697091CE6}"/>
              </a:ext>
            </a:extLst>
          </p:cNvPr>
          <p:cNvSpPr txBox="1"/>
          <p:nvPr/>
        </p:nvSpPr>
        <p:spPr>
          <a:xfrm>
            <a:off x="7087945" y="4342815"/>
            <a:ext cx="482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1A7E474-786B-52EA-1E62-4D1B7D722DA7}"/>
              </a:ext>
            </a:extLst>
          </p:cNvPr>
          <p:cNvSpPr txBox="1"/>
          <p:nvPr/>
        </p:nvSpPr>
        <p:spPr>
          <a:xfrm>
            <a:off x="6992298" y="1610174"/>
            <a:ext cx="560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5697B53-C196-7125-6249-84EF2197D00D}"/>
              </a:ext>
            </a:extLst>
          </p:cNvPr>
          <p:cNvSpPr txBox="1"/>
          <p:nvPr/>
        </p:nvSpPr>
        <p:spPr>
          <a:xfrm>
            <a:off x="7435761" y="1569311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75F2CEB-126F-F1EF-363F-1A9056181244}"/>
              </a:ext>
            </a:extLst>
          </p:cNvPr>
          <p:cNvSpPr txBox="1"/>
          <p:nvPr/>
        </p:nvSpPr>
        <p:spPr>
          <a:xfrm rot="18877941">
            <a:off x="7967937" y="1238720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9058582-C509-8684-1F43-CB0E87FC0933}"/>
              </a:ext>
            </a:extLst>
          </p:cNvPr>
          <p:cNvSpPr txBox="1"/>
          <p:nvPr/>
        </p:nvSpPr>
        <p:spPr>
          <a:xfrm rot="18877941">
            <a:off x="8484672" y="1238720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0E25C4FD-1E0C-5F41-D2D8-D6716FC1523A}"/>
              </a:ext>
            </a:extLst>
          </p:cNvPr>
          <p:cNvSpPr txBox="1"/>
          <p:nvPr/>
        </p:nvSpPr>
        <p:spPr>
          <a:xfrm rot="18877941">
            <a:off x="8990219" y="1238719"/>
            <a:ext cx="126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B624D88-F6AD-7603-2B5C-9B723C74C6E4}"/>
              </a:ext>
            </a:extLst>
          </p:cNvPr>
          <p:cNvSpPr txBox="1"/>
          <p:nvPr/>
        </p:nvSpPr>
        <p:spPr>
          <a:xfrm rot="18877941">
            <a:off x="9380045" y="1106916"/>
            <a:ext cx="1693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A-VP2-VP3-VP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A2AD2572-9143-ECE6-A39F-883FB40F58B0}"/>
              </a:ext>
            </a:extLst>
          </p:cNvPr>
          <p:cNvSpPr txBox="1"/>
          <p:nvPr/>
        </p:nvSpPr>
        <p:spPr>
          <a:xfrm>
            <a:off x="3064667" y="5007464"/>
            <a:ext cx="1269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 E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0399805-2506-65FB-A614-4B28521C49F5}"/>
              </a:ext>
            </a:extLst>
          </p:cNvPr>
          <p:cNvSpPr txBox="1"/>
          <p:nvPr/>
        </p:nvSpPr>
        <p:spPr>
          <a:xfrm>
            <a:off x="8434863" y="5372922"/>
            <a:ext cx="1269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 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3D081BD-0559-736F-68D8-A193128F34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8098" y="2073482"/>
            <a:ext cx="3966136" cy="2647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1903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2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 K</dc:creator>
  <cp:lastModifiedBy>MDPI</cp:lastModifiedBy>
  <cp:revision>6</cp:revision>
  <dcterms:created xsi:type="dcterms:W3CDTF">2025-12-30T13:09:17Z</dcterms:created>
  <dcterms:modified xsi:type="dcterms:W3CDTF">2026-01-15T09:38:58Z</dcterms:modified>
</cp:coreProperties>
</file>